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7" r:id="rId2"/>
    <p:sldId id="266" r:id="rId3"/>
    <p:sldId id="268" r:id="rId4"/>
    <p:sldId id="269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6511" autoAdjust="0"/>
  </p:normalViewPr>
  <p:slideViewPr>
    <p:cSldViewPr snapToGrid="0">
      <p:cViewPr varScale="1">
        <p:scale>
          <a:sx n="116" d="100"/>
          <a:sy n="116" d="100"/>
        </p:scale>
        <p:origin x="146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3AC81C-16C7-4E23-8C25-125CA06D8B41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E1423-19C7-4A78-97DD-86233D9654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257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1296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 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323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 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8478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276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8362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942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5818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301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607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 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451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265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73596F-E56B-4C09-8795-2700F9071DAA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E31ED-1183-4A89-8C55-DF08578E3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096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74141" y="6409038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1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/>
          <a:srcRect l="11553" t="19485" r="20132" b="7353"/>
          <a:stretch/>
        </p:blipFill>
        <p:spPr>
          <a:xfrm>
            <a:off x="432000" y="936230"/>
            <a:ext cx="8280000" cy="4985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7020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74141" y="6409038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2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/>
          <a:srcRect l="20985" t="27590" r="19881" b="8304"/>
          <a:stretch/>
        </p:blipFill>
        <p:spPr>
          <a:xfrm>
            <a:off x="478523" y="905639"/>
            <a:ext cx="8280000" cy="50467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4015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250" y="185389"/>
            <a:ext cx="8437501" cy="6075368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74141" y="6409038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3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534" y="7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5534" y="305966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20436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4141" y="6409038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/>
              <a:t>4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534" y="7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5534" y="305966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084" y="185389"/>
            <a:ext cx="8455832" cy="6100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9023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52</TotalTime>
  <Words>16</Words>
  <Application>Microsoft Office PowerPoint</Application>
  <PresentationFormat>画面に合わせる (4:3)</PresentationFormat>
  <Paragraphs>8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症例番号</dc:title>
  <dc:creator>CM1-11542</dc:creator>
  <cp:lastModifiedBy>中村康平</cp:lastModifiedBy>
  <cp:revision>86</cp:revision>
  <dcterms:created xsi:type="dcterms:W3CDTF">2017-06-27T07:48:54Z</dcterms:created>
  <dcterms:modified xsi:type="dcterms:W3CDTF">2020-05-18T19:52:08Z</dcterms:modified>
</cp:coreProperties>
</file>